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43"/>
    <p:restoredTop sz="96327"/>
  </p:normalViewPr>
  <p:slideViewPr>
    <p:cSldViewPr snapToGrid="0" snapToObjects="1">
      <p:cViewPr varScale="1">
        <p:scale>
          <a:sx n="124" d="100"/>
          <a:sy n="124" d="100"/>
        </p:scale>
        <p:origin x="53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8ECC03-122C-444D-9F05-CC163EDAFCF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6802C05-E3E0-4A41-B960-2A9D7BD8D7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F0F60F-3F3C-6D4C-A05F-E6A1DFBF0C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B9318-E8CF-B347-AB85-BD3C8E751ECD}" type="datetimeFigureOut">
              <a:rPr lang="en-US" smtClean="0"/>
              <a:t>4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66B1CF-8112-5549-8E73-E609C76D9E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6A5C9E-B2D6-EF4F-942C-D09B897295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300D8-E0D8-664D-B92F-23532CFAB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448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85D9A5-F413-354C-A18F-51677AD113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FDA47EB-4C2C-2741-A8FB-730E7F0898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5F0E31-D3AE-7246-9BE0-BDDBAA7021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B9318-E8CF-B347-AB85-BD3C8E751ECD}" type="datetimeFigureOut">
              <a:rPr lang="en-US" smtClean="0"/>
              <a:t>4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6E395B-27C1-D143-82C9-FE8689C4D6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AFBAA5-963C-7547-82A9-0F101F777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300D8-E0D8-664D-B92F-23532CFAB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01109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4A61CEF-9CBF-9949-835C-1E28199ABC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AB4973-1B13-4841-91C6-87B9F7FBC4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F54EDD-802E-9245-A11B-5AD093BFB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B9318-E8CF-B347-AB85-BD3C8E751ECD}" type="datetimeFigureOut">
              <a:rPr lang="en-US" smtClean="0"/>
              <a:t>4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8BB586-31CB-9943-B32E-E58D77AF55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CF0CFE-53FF-9B47-9F3E-219C4BD654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300D8-E0D8-664D-B92F-23532CFAB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9533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38DDBF-3717-194A-913C-CCCDEF155A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826075-9D31-1E45-9242-9895A327E7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70269D-BBEE-4F42-8F2A-2C0B0EFD1C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B9318-E8CF-B347-AB85-BD3C8E751ECD}" type="datetimeFigureOut">
              <a:rPr lang="en-US" smtClean="0"/>
              <a:t>4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9B0F7D-EB51-404A-8077-32DF3F2997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B6A4DA-17A7-6E46-B241-77172FF813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300D8-E0D8-664D-B92F-23532CFAB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395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2C215B-488E-BA46-B3B1-8B44A9C4EE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83EC28-140B-4E4E-9C5B-8B064E0F1B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6A0C57-D703-2549-AAA4-1ACC7D0AB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B9318-E8CF-B347-AB85-BD3C8E751ECD}" type="datetimeFigureOut">
              <a:rPr lang="en-US" smtClean="0"/>
              <a:t>4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FBD815-169C-7240-8712-DD4E738EDE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AD143F-3015-D746-A587-4C40E632E5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300D8-E0D8-664D-B92F-23532CFAB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0005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BB5042-7AD6-0A40-A8A3-6AB293BD41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A5F2F5-4873-1E40-A2A3-8B97CBFB6E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B5ABFE0-F55E-BD46-95EE-655093DEE4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332FDC-75B9-3247-B616-655EB7C18C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B9318-E8CF-B347-AB85-BD3C8E751ECD}" type="datetimeFigureOut">
              <a:rPr lang="en-US" smtClean="0"/>
              <a:t>4/2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326275-CFBE-2940-BF87-157F0F38E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02E3EB-6970-E14C-ACB8-2DD68B82CC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300D8-E0D8-664D-B92F-23532CFAB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7350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4B468C-C019-4A4D-93AF-B95C83DFC7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4639F2-6146-B045-BC94-7458D6A87B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D8A777-D021-B44C-B7C5-9558D9D289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15EEBC3-ED81-0140-AF23-65857A908D9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C38413A-EC49-D14E-BF32-F0389D62F8E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B590BBB-E7D4-ED49-BED7-08B4D39079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B9318-E8CF-B347-AB85-BD3C8E751ECD}" type="datetimeFigureOut">
              <a:rPr lang="en-US" smtClean="0"/>
              <a:t>4/24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5C6A442-6308-4248-A24B-69924C6887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633C4FB-0B9B-734F-AEC7-E687079242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300D8-E0D8-664D-B92F-23532CFAB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5348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C2BCB9-1DD8-C147-8331-4475FCC87B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E473464-9D1F-3B4B-94A9-A442DDC5FA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B9318-E8CF-B347-AB85-BD3C8E751ECD}" type="datetimeFigureOut">
              <a:rPr lang="en-US" smtClean="0"/>
              <a:t>4/24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1BC9EB-4875-D548-BF7D-AE82C8BF73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B3CC8DA-1B81-354C-979A-8E8AD863BC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300D8-E0D8-664D-B92F-23532CFAB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5410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F4F1D62-B857-4E44-BE99-FC3FFA6A7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B9318-E8CF-B347-AB85-BD3C8E751ECD}" type="datetimeFigureOut">
              <a:rPr lang="en-US" smtClean="0"/>
              <a:t>4/24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3EA0220-9F2A-204C-A291-7BCE71C358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84E1033-260C-7C4E-996C-DFDEFDFAB1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300D8-E0D8-664D-B92F-23532CFAB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7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72091C-E496-F645-9BFE-984A41F811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2A4864-68A6-0B44-BA43-84BB79C9B9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BA526A1-A76B-C146-97C9-8B632CAA5E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FE4884-E052-5B4A-AC88-47617A594D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B9318-E8CF-B347-AB85-BD3C8E751ECD}" type="datetimeFigureOut">
              <a:rPr lang="en-US" smtClean="0"/>
              <a:t>4/2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1A56AB-E456-7C4D-92A2-091F5E4DD4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0858B4-14AC-4B48-81F8-89DA97E515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300D8-E0D8-664D-B92F-23532CFAB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8330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7FFBFD-473F-814A-B03F-D87B50C5A9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96EA93C-7300-2849-BA44-132A7C8E24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163DB88-A084-CF40-AF86-D40CF356C2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EB8445-B5DE-124E-B04F-9D0959F55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B9318-E8CF-B347-AB85-BD3C8E751ECD}" type="datetimeFigureOut">
              <a:rPr lang="en-US" smtClean="0"/>
              <a:t>4/2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F109F4-7E9A-BD49-B26F-7356859D83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D9103B-3FAC-FA42-ACC2-05F62F3AC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300D8-E0D8-664D-B92F-23532CFAB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140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473B705-5E67-B248-B580-DF9F3F24E2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60B968-496E-CC46-9E96-B9617336F3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591C68-E710-3841-9870-7ADDA80B7B8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6B9318-E8CF-B347-AB85-BD3C8E751ECD}" type="datetimeFigureOut">
              <a:rPr lang="en-US" smtClean="0"/>
              <a:t>4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4459AB-13A4-684F-B26F-9050E69E099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38C071-E615-F344-9527-7CCAFE5E960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C300D8-E0D8-664D-B92F-23532CFAB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86231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5E27DC-B3BF-C542-8635-B54CC70C5234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ILAE Genetics Literacy Series: Progressive Myoclonus Epilepsie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8689AF0-77B2-2941-BAE8-C6EA99A12026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Dr Jillian M. Cameron, Dr Colin A. Ellis, Professor Samuel F. </a:t>
            </a:r>
            <a:r>
              <a:rPr lang="en-US" dirty="0" err="1"/>
              <a:t>Berkovi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99832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B9122E-65B0-884A-A5FC-E7F9059899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ogressive Myoclonus Epilepsy (PME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5F9C52-7182-F84F-8E71-6A96D867C24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 rare epilepsy syndrome characterised by the development of progressively worsening myoclonus, ataxia and tonic-</a:t>
            </a:r>
            <a:r>
              <a:rPr lang="en-US" dirty="0" err="1"/>
              <a:t>clonic</a:t>
            </a:r>
            <a:r>
              <a:rPr lang="en-US" dirty="0"/>
              <a:t> seizures</a:t>
            </a:r>
          </a:p>
          <a:p>
            <a:r>
              <a:rPr lang="en-US" dirty="0"/>
              <a:t>Many forms of PME, with over 40 established genetic causes</a:t>
            </a:r>
          </a:p>
          <a:p>
            <a:r>
              <a:rPr lang="en-US" dirty="0"/>
              <a:t>More commonly encountered PMEs include</a:t>
            </a:r>
          </a:p>
          <a:p>
            <a:pPr lvl="1"/>
            <a:r>
              <a:rPr lang="en-US" dirty="0" err="1"/>
              <a:t>Unverricht</a:t>
            </a:r>
            <a:r>
              <a:rPr lang="en-US" dirty="0"/>
              <a:t> </a:t>
            </a:r>
            <a:r>
              <a:rPr lang="en-US" dirty="0" err="1"/>
              <a:t>Lundborg</a:t>
            </a:r>
            <a:r>
              <a:rPr lang="en-US" dirty="0"/>
              <a:t> Disease</a:t>
            </a:r>
          </a:p>
          <a:p>
            <a:pPr lvl="1"/>
            <a:r>
              <a:rPr lang="en-US" dirty="0"/>
              <a:t>Lafora Disease</a:t>
            </a:r>
          </a:p>
          <a:p>
            <a:pPr lvl="1"/>
            <a:r>
              <a:rPr lang="en-US" dirty="0"/>
              <a:t>Neuronal Ceroid Lipofuscinoses</a:t>
            </a:r>
          </a:p>
          <a:p>
            <a:pPr lvl="1"/>
            <a:r>
              <a:rPr lang="en-US" dirty="0"/>
              <a:t>Myoclonic Epilepsy with Ragged Red </a:t>
            </a:r>
            <a:r>
              <a:rPr lang="en-US" dirty="0" err="1"/>
              <a:t>Fibres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879666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7FAB83-9285-F340-AE5B-6C41DBC145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ME: Investigation strategi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064117-45BF-4745-A2AD-21C5C072F88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77500" lnSpcReduction="20000"/>
          </a:bodyPr>
          <a:lstStyle/>
          <a:p>
            <a:r>
              <a:rPr lang="en-US" dirty="0">
                <a:effectLst/>
                <a:ea typeface="Calibri" panose="020F0502020204030204" pitchFamily="34" charset="0"/>
              </a:rPr>
              <a:t>PME should be considered in patients with myoclonus (especially if refractory to medication), progressive motor impairment, cognitive deterioration, sensory and cerebellar signs</a:t>
            </a:r>
            <a:r>
              <a:rPr lang="en-AU" dirty="0">
                <a:effectLst/>
              </a:rPr>
              <a:t> </a:t>
            </a:r>
          </a:p>
          <a:p>
            <a:r>
              <a:rPr lang="en-AU" dirty="0"/>
              <a:t>Certain clinical and EEG findings can help to narrow the differential diagnoses to specific causes</a:t>
            </a:r>
            <a:r>
              <a:rPr lang="en-US" dirty="0"/>
              <a:t> </a:t>
            </a:r>
          </a:p>
          <a:p>
            <a:r>
              <a:rPr lang="en-US" dirty="0">
                <a:effectLst/>
                <a:ea typeface="Calibri" panose="020F0502020204030204" pitchFamily="34" charset="0"/>
              </a:rPr>
              <a:t>Genetic testing should now be the first-line diagnostic test whenever PME is suspected </a:t>
            </a:r>
          </a:p>
          <a:p>
            <a:pPr lvl="1"/>
            <a:r>
              <a:rPr lang="en-US" dirty="0"/>
              <a:t>A molecular diagnosis can now be made in 80% of individuals with PME</a:t>
            </a:r>
          </a:p>
          <a:p>
            <a:r>
              <a:rPr lang="en-US" dirty="0">
                <a:effectLst/>
                <a:ea typeface="Calibri" panose="020F0502020204030204" pitchFamily="34" charset="0"/>
              </a:rPr>
              <a:t>PME gene panels are currently useful, however exome or genome sequencing have additional advantages </a:t>
            </a:r>
          </a:p>
          <a:p>
            <a:pPr lvl="1"/>
            <a:r>
              <a:rPr lang="en-US" dirty="0">
                <a:effectLst/>
                <a:ea typeface="Calibri" panose="020F0502020204030204" pitchFamily="34" charset="0"/>
              </a:rPr>
              <a:t>These include detection </a:t>
            </a:r>
            <a:r>
              <a:rPr lang="en-US" dirty="0">
                <a:ea typeface="Calibri" panose="020F0502020204030204" pitchFamily="34" charset="0"/>
              </a:rPr>
              <a:t>of findings not detected by gene panel, and allowing future reanalysis </a:t>
            </a:r>
            <a:r>
              <a:rPr lang="en-US">
                <a:ea typeface="Calibri" panose="020F0502020204030204" pitchFamily="34" charset="0"/>
              </a:rPr>
              <a:t>for those </a:t>
            </a:r>
            <a:r>
              <a:rPr lang="en-US" dirty="0">
                <a:ea typeface="Calibri" panose="020F0502020204030204" pitchFamily="34" charset="0"/>
              </a:rPr>
              <a:t>who remain without a diagnosis</a:t>
            </a:r>
          </a:p>
          <a:p>
            <a:pPr lvl="1"/>
            <a:r>
              <a:rPr lang="en-US" dirty="0">
                <a:ea typeface="Calibri" panose="020F0502020204030204" pitchFamily="34" charset="0"/>
              </a:rPr>
              <a:t>Testing for repeat expansions (e.g. in </a:t>
            </a:r>
            <a:r>
              <a:rPr lang="en-US" dirty="0" err="1">
                <a:ea typeface="Calibri" panose="020F0502020204030204" pitchFamily="34" charset="0"/>
              </a:rPr>
              <a:t>Unverricht-Lundborg</a:t>
            </a:r>
            <a:r>
              <a:rPr lang="en-US" dirty="0">
                <a:ea typeface="Calibri" panose="020F0502020204030204" pitchFamily="34" charset="0"/>
              </a:rPr>
              <a:t> disease) and for mitochondrial disorders may need to be specifically requested. </a:t>
            </a:r>
            <a:endParaRPr lang="en-US" dirty="0">
              <a:effectLst/>
              <a:ea typeface="Calibri" panose="020F0502020204030204" pitchFamily="34" charset="0"/>
            </a:endParaRPr>
          </a:p>
          <a:p>
            <a:r>
              <a:rPr lang="en-US" dirty="0">
                <a:effectLst/>
                <a:ea typeface="Calibri" panose="020F0502020204030204" pitchFamily="34" charset="0"/>
              </a:rPr>
              <a:t>WES/WGS will likely soon replace gene panels as first-line genetic tests for individuals with PME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4930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03B171-47AC-1140-A031-CE69CC4017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ME: Treatment strategi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387818-4E5F-704B-8475-70E39F5ABB5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r>
              <a:rPr lang="en-US" dirty="0"/>
              <a:t>For most types of PME, no disease modifying treatments exist</a:t>
            </a:r>
          </a:p>
          <a:p>
            <a:pPr lvl="1"/>
            <a:r>
              <a:rPr lang="en-US" dirty="0"/>
              <a:t>With the exception of intraventricular enzyme replacement therapy for CLN2 disease </a:t>
            </a:r>
          </a:p>
          <a:p>
            <a:r>
              <a:rPr lang="en-US" dirty="0"/>
              <a:t>Treatments strategies for the majority of individuals with PME are currently symptomatic, aimed at seizure control and suppression of myoclonus</a:t>
            </a:r>
          </a:p>
          <a:p>
            <a:pPr lvl="1"/>
            <a:r>
              <a:rPr lang="en-US" dirty="0"/>
              <a:t>Anti-seizure medications mainstay of treatment</a:t>
            </a:r>
          </a:p>
          <a:p>
            <a:pPr lvl="1"/>
            <a:r>
              <a:rPr lang="en-US" dirty="0"/>
              <a:t>Limited evidence for some adjunctive therapies including dietary and </a:t>
            </a:r>
            <a:r>
              <a:rPr lang="en-US" dirty="0" err="1"/>
              <a:t>neuromodulatory</a:t>
            </a:r>
            <a:r>
              <a:rPr lang="en-US" dirty="0"/>
              <a:t> therapies</a:t>
            </a:r>
          </a:p>
          <a:p>
            <a:r>
              <a:rPr lang="en-US" dirty="0"/>
              <a:t>Precision medicine therapeutic strategies for many forms of PME remain under early stages of investigation</a:t>
            </a:r>
          </a:p>
        </p:txBody>
      </p:sp>
    </p:spTree>
    <p:extLst>
      <p:ext uri="{BB962C8B-B14F-4D97-AF65-F5344CB8AC3E}">
        <p14:creationId xmlns:p14="http://schemas.microsoft.com/office/powerpoint/2010/main" val="3493739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306</Words>
  <Application>Microsoft Macintosh PowerPoint</Application>
  <PresentationFormat>Widescreen</PresentationFormat>
  <Paragraphs>2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ILAE Genetics Literacy Series: Progressive Myoclonus Epilepsies</vt:lpstr>
      <vt:lpstr>Progressive Myoclonus Epilepsy (PME)</vt:lpstr>
      <vt:lpstr>PME: Investigation strategies</vt:lpstr>
      <vt:lpstr>PME: Treatment strategi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LAE Genetics Literacy Series: Progressive Myoclonus Epilepsies</dc:title>
  <dc:creator>Jillian Cameron</dc:creator>
  <cp:lastModifiedBy>Jillian Cameron</cp:lastModifiedBy>
  <cp:revision>4</cp:revision>
  <dcterms:created xsi:type="dcterms:W3CDTF">2023-04-17T11:06:59Z</dcterms:created>
  <dcterms:modified xsi:type="dcterms:W3CDTF">2023-04-24T01:46:58Z</dcterms:modified>
</cp:coreProperties>
</file>